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38" userDrawn="1">
          <p15:clr>
            <a:srgbClr val="A4A3A4"/>
          </p15:clr>
        </p15:guide>
        <p15:guide id="2" pos="75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4" d="100"/>
          <a:sy n="64" d="100"/>
        </p:scale>
        <p:origin x="3318" y="90"/>
      </p:cViewPr>
      <p:guideLst>
        <p:guide orient="horz" pos="4838"/>
        <p:guide pos="75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4203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8503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8675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1631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5303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8801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6677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8994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7053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7983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5194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8302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83B94C3D-6867-4072-9F6F-363CA9B879CB}"/>
              </a:ext>
            </a:extLst>
          </p:cNvPr>
          <p:cNvSpPr txBox="1"/>
          <p:nvPr/>
        </p:nvSpPr>
        <p:spPr>
          <a:xfrm>
            <a:off x="542925" y="10740848"/>
            <a:ext cx="577215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</a:t>
            </a:r>
            <a:r>
              <a:rPr lang="en-US" sz="1200" b="1"/>
              <a:t>Figure 2. </a:t>
            </a:r>
            <a:r>
              <a:rPr lang="en-US" sz="1200" b="1" dirty="0"/>
              <a:t>Distribution of individual total (combined adenomatous and serrated polyp) colorectal polyp counts according to seAFOod trial treatment allocation by factorial margins and ALOX SNP genotypes. </a:t>
            </a:r>
            <a:r>
              <a:rPr lang="en-US" sz="1200" dirty="0"/>
              <a:t>The difference between total colorectal polyp number between treatment groups for each genotype was compared using the Kruskal-Wallis rank test.</a:t>
            </a:r>
            <a:endParaRPr lang="en-GB" sz="1200" b="1" dirty="0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8481" y="5557837"/>
            <a:ext cx="1664496" cy="1181992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4253" y="5556988"/>
            <a:ext cx="1664496" cy="1192367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4734" y="5555941"/>
            <a:ext cx="1639084" cy="1193401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5425" y="6739890"/>
            <a:ext cx="1646238" cy="1179314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4203" y="6738848"/>
            <a:ext cx="1654546" cy="1179314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3575" y="6749486"/>
            <a:ext cx="1639084" cy="1168676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5425" y="8009299"/>
            <a:ext cx="1639924" cy="119267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6018" y="8009299"/>
            <a:ext cx="1639925" cy="1192672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0011" y="8013700"/>
            <a:ext cx="1639085" cy="1192061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4381" y="9196113"/>
            <a:ext cx="1679821" cy="1209994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4203" y="9204769"/>
            <a:ext cx="1644418" cy="118987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0012" y="9201971"/>
            <a:ext cx="1631740" cy="118987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8750" y="740033"/>
            <a:ext cx="1650207" cy="120015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8956" y="727324"/>
            <a:ext cx="1664496" cy="121054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3452" y="742910"/>
            <a:ext cx="1646238" cy="119726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8755" y="1933370"/>
            <a:ext cx="1646239" cy="119838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1750" y="1933370"/>
            <a:ext cx="1667740" cy="119838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2657" y="1933443"/>
            <a:ext cx="1646238" cy="119838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7167" y="3222240"/>
            <a:ext cx="1649414" cy="112617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8098" y="3223580"/>
            <a:ext cx="1660536" cy="112617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8621" y="3218817"/>
            <a:ext cx="1646239" cy="1139302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2718" y="4350608"/>
            <a:ext cx="1646238" cy="1105235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6576" y="4349971"/>
            <a:ext cx="1654858" cy="118164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3876" y="4337796"/>
            <a:ext cx="1639974" cy="1193820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A8E95DFF-426E-4ED4-B655-84A1D8F76E6C}"/>
              </a:ext>
            </a:extLst>
          </p:cNvPr>
          <p:cNvSpPr txBox="1"/>
          <p:nvPr/>
        </p:nvSpPr>
        <p:spPr>
          <a:xfrm rot="16200000">
            <a:off x="-320194" y="1797391"/>
            <a:ext cx="2391716" cy="27699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rs7090328</a:t>
            </a:r>
            <a:endParaRPr lang="en-GB" sz="12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11AF482-6B70-413D-8A6E-6BC410548E17}"/>
              </a:ext>
            </a:extLst>
          </p:cNvPr>
          <p:cNvSpPr txBox="1"/>
          <p:nvPr/>
        </p:nvSpPr>
        <p:spPr>
          <a:xfrm rot="16200000">
            <a:off x="-238313" y="4203368"/>
            <a:ext cx="2227954" cy="27699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rs2073438</a:t>
            </a:r>
            <a:endParaRPr lang="en-GB" sz="12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8F34606-41CB-440D-A099-4D26CC4A06E7}"/>
              </a:ext>
            </a:extLst>
          </p:cNvPr>
          <p:cNvSpPr txBox="1"/>
          <p:nvPr/>
        </p:nvSpPr>
        <p:spPr>
          <a:xfrm>
            <a:off x="1775833" y="843812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71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651D009-5414-4AC3-B529-6FBD1A9CE334}"/>
              </a:ext>
            </a:extLst>
          </p:cNvPr>
          <p:cNvSpPr txBox="1"/>
          <p:nvPr/>
        </p:nvSpPr>
        <p:spPr>
          <a:xfrm>
            <a:off x="5090848" y="2057443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4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1212D8F-46E8-4F7B-A7BD-F9009A5F80E7}"/>
              </a:ext>
            </a:extLst>
          </p:cNvPr>
          <p:cNvSpPr txBox="1"/>
          <p:nvPr/>
        </p:nvSpPr>
        <p:spPr>
          <a:xfrm>
            <a:off x="3377835" y="2057435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38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4340032-7621-46CA-9485-3BC506781DB3}"/>
              </a:ext>
            </a:extLst>
          </p:cNvPr>
          <p:cNvSpPr txBox="1"/>
          <p:nvPr/>
        </p:nvSpPr>
        <p:spPr>
          <a:xfrm>
            <a:off x="1775254" y="2060063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2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B7F32C1-DDF0-48EC-895C-541E523F285A}"/>
              </a:ext>
            </a:extLst>
          </p:cNvPr>
          <p:cNvSpPr txBox="1"/>
          <p:nvPr/>
        </p:nvSpPr>
        <p:spPr>
          <a:xfrm>
            <a:off x="5090848" y="843812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01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65432A4-2056-4B30-BB05-B485FA0EB08A}"/>
              </a:ext>
            </a:extLst>
          </p:cNvPr>
          <p:cNvSpPr txBox="1"/>
          <p:nvPr/>
        </p:nvSpPr>
        <p:spPr>
          <a:xfrm>
            <a:off x="3377835" y="843812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4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F934206-C3F0-493D-A0B4-DC76552E9F28}"/>
              </a:ext>
            </a:extLst>
          </p:cNvPr>
          <p:cNvSpPr txBox="1"/>
          <p:nvPr/>
        </p:nvSpPr>
        <p:spPr>
          <a:xfrm>
            <a:off x="1775254" y="3334202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02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982E29F-06A5-44F5-BB79-6F9074766B0E}"/>
              </a:ext>
            </a:extLst>
          </p:cNvPr>
          <p:cNvSpPr txBox="1"/>
          <p:nvPr/>
        </p:nvSpPr>
        <p:spPr>
          <a:xfrm>
            <a:off x="5089591" y="4457878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29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1A706CF-1C01-4CF8-91E0-8EBF73984A1E}"/>
              </a:ext>
            </a:extLst>
          </p:cNvPr>
          <p:cNvSpPr txBox="1"/>
          <p:nvPr/>
        </p:nvSpPr>
        <p:spPr>
          <a:xfrm>
            <a:off x="3370636" y="4457200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78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0570187-0B2E-4EF4-9DCC-8876DC7C8DF0}"/>
              </a:ext>
            </a:extLst>
          </p:cNvPr>
          <p:cNvSpPr txBox="1"/>
          <p:nvPr/>
        </p:nvSpPr>
        <p:spPr>
          <a:xfrm>
            <a:off x="1774096" y="4460743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4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730FDC2-023C-4CE3-94DC-FC54BC9BC0A9}"/>
              </a:ext>
            </a:extLst>
          </p:cNvPr>
          <p:cNvSpPr txBox="1"/>
          <p:nvPr/>
        </p:nvSpPr>
        <p:spPr>
          <a:xfrm>
            <a:off x="5089591" y="3336886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76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BC72466-E94D-4641-BFE9-FF54BD4A59FF}"/>
              </a:ext>
            </a:extLst>
          </p:cNvPr>
          <p:cNvSpPr txBox="1"/>
          <p:nvPr/>
        </p:nvSpPr>
        <p:spPr>
          <a:xfrm>
            <a:off x="3374232" y="3328340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91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197CD12-7001-49D1-824F-74315F1739A6}"/>
              </a:ext>
            </a:extLst>
          </p:cNvPr>
          <p:cNvSpPr txBox="1"/>
          <p:nvPr/>
        </p:nvSpPr>
        <p:spPr>
          <a:xfrm rot="16200000">
            <a:off x="-308483" y="6595517"/>
            <a:ext cx="2368294" cy="27699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rs2920421</a:t>
            </a:r>
            <a:endParaRPr lang="en-GB" sz="12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2E8AE87-2C07-4E7A-8F3C-13F8D7054141}"/>
              </a:ext>
            </a:extLst>
          </p:cNvPr>
          <p:cNvSpPr txBox="1"/>
          <p:nvPr/>
        </p:nvSpPr>
        <p:spPr>
          <a:xfrm rot="16200000">
            <a:off x="-317210" y="9064272"/>
            <a:ext cx="2378141" cy="27699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rs2271316</a:t>
            </a:r>
            <a:endParaRPr lang="en-GB" sz="12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14E1B17-87ED-41DB-A929-CB8B04A1EA8D}"/>
              </a:ext>
            </a:extLst>
          </p:cNvPr>
          <p:cNvSpPr txBox="1"/>
          <p:nvPr/>
        </p:nvSpPr>
        <p:spPr>
          <a:xfrm>
            <a:off x="5084417" y="5694363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82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1D82D12-7C00-40F3-87A3-9527F0A0D8E6}"/>
              </a:ext>
            </a:extLst>
          </p:cNvPr>
          <p:cNvSpPr txBox="1"/>
          <p:nvPr/>
        </p:nvSpPr>
        <p:spPr>
          <a:xfrm>
            <a:off x="3365462" y="5693685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9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8E921C9-5C82-40C5-ACC7-C0536355C4FA}"/>
              </a:ext>
            </a:extLst>
          </p:cNvPr>
          <p:cNvSpPr txBox="1"/>
          <p:nvPr/>
        </p:nvSpPr>
        <p:spPr>
          <a:xfrm>
            <a:off x="1768922" y="5697228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02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CA98A93-AF6D-4171-9780-64D0D447A2CD}"/>
              </a:ext>
            </a:extLst>
          </p:cNvPr>
          <p:cNvSpPr txBox="1"/>
          <p:nvPr/>
        </p:nvSpPr>
        <p:spPr>
          <a:xfrm>
            <a:off x="5093187" y="6886109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19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E0BBAF3-CE34-4B63-B9E0-0B3E9DA711D9}"/>
              </a:ext>
            </a:extLst>
          </p:cNvPr>
          <p:cNvSpPr txBox="1"/>
          <p:nvPr/>
        </p:nvSpPr>
        <p:spPr>
          <a:xfrm>
            <a:off x="3374232" y="6885431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6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7C73CB3-443A-4E5A-A5EE-DDDEBD63C813}"/>
              </a:ext>
            </a:extLst>
          </p:cNvPr>
          <p:cNvSpPr txBox="1"/>
          <p:nvPr/>
        </p:nvSpPr>
        <p:spPr>
          <a:xfrm>
            <a:off x="1777692" y="6888974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1CAA1B6-0EBA-4766-B84A-89FA99C55EE1}"/>
              </a:ext>
            </a:extLst>
          </p:cNvPr>
          <p:cNvSpPr txBox="1"/>
          <p:nvPr/>
        </p:nvSpPr>
        <p:spPr>
          <a:xfrm>
            <a:off x="5082792" y="8142199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78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AB44ACA-995B-49E5-BA2B-44B006F3225D}"/>
              </a:ext>
            </a:extLst>
          </p:cNvPr>
          <p:cNvSpPr txBox="1"/>
          <p:nvPr/>
        </p:nvSpPr>
        <p:spPr>
          <a:xfrm>
            <a:off x="3363837" y="8141521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91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08D2C5C-6219-427F-9C45-DE8CD030A198}"/>
              </a:ext>
            </a:extLst>
          </p:cNvPr>
          <p:cNvSpPr txBox="1"/>
          <p:nvPr/>
        </p:nvSpPr>
        <p:spPr>
          <a:xfrm>
            <a:off x="1767297" y="8145064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0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4E12CA6-2AA8-49B4-8A5E-54502876AD41}"/>
              </a:ext>
            </a:extLst>
          </p:cNvPr>
          <p:cNvSpPr txBox="1"/>
          <p:nvPr/>
        </p:nvSpPr>
        <p:spPr>
          <a:xfrm>
            <a:off x="5096790" y="9336280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36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F5B3D94-5A8A-4FAA-B1FE-CFF7DEB18BCB}"/>
              </a:ext>
            </a:extLst>
          </p:cNvPr>
          <p:cNvSpPr txBox="1"/>
          <p:nvPr/>
        </p:nvSpPr>
        <p:spPr>
          <a:xfrm>
            <a:off x="3377835" y="9335602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8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E55BFE7D-69C2-432F-8B07-119884CBD532}"/>
              </a:ext>
            </a:extLst>
          </p:cNvPr>
          <p:cNvSpPr txBox="1"/>
          <p:nvPr/>
        </p:nvSpPr>
        <p:spPr>
          <a:xfrm>
            <a:off x="1781295" y="9339145"/>
            <a:ext cx="566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22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38622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7</TotalTime>
  <Words>81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Leed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Hull</dc:creator>
  <cp:lastModifiedBy>Mark Hull</cp:lastModifiedBy>
  <cp:revision>19</cp:revision>
  <dcterms:created xsi:type="dcterms:W3CDTF">2022-12-05T11:01:53Z</dcterms:created>
  <dcterms:modified xsi:type="dcterms:W3CDTF">2023-09-05T06:46:55Z</dcterms:modified>
</cp:coreProperties>
</file>